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9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42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37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6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73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15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4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5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568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2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8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1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25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CB8E328-F989-4FBE-A468-8F04B9912CFC}"/>
              </a:ext>
            </a:extLst>
          </p:cNvPr>
          <p:cNvSpPr txBox="1"/>
          <p:nvPr/>
        </p:nvSpPr>
        <p:spPr>
          <a:xfrm>
            <a:off x="176527" y="569508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8459EF0-3E3D-4932-8E8A-A9C3788EAB00}"/>
              </a:ext>
            </a:extLst>
          </p:cNvPr>
          <p:cNvSpPr txBox="1"/>
          <p:nvPr/>
        </p:nvSpPr>
        <p:spPr>
          <a:xfrm>
            <a:off x="176527" y="4118480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4B45EEE-BFCA-4E09-98AB-4F76187356C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37226"/>
            <a:ext cx="6858000" cy="31812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98E543A-82CE-44D4-81C2-5E7694B51B9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86198"/>
            <a:ext cx="6858000" cy="318125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C941449-AAB2-F6AB-DB63-A39546127366}"/>
              </a:ext>
            </a:extLst>
          </p:cNvPr>
          <p:cNvSpPr txBox="1"/>
          <p:nvPr/>
        </p:nvSpPr>
        <p:spPr>
          <a:xfrm>
            <a:off x="274981" y="8164051"/>
            <a:ext cx="630803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es of recombination crossover points in the UL and US sub-regions. The UL (A) and US (B) sub-region of the AH/1807 strain was selected as query, and the corresponding sub-regions of the ATE2539 European strain, GA North American strain, and CVI988 reference vaccine strain were chosen to perform bootscan analysis using Simplot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983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</TotalTime>
  <Words>68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 Li</dc:creator>
  <cp:lastModifiedBy>Andy Lee</cp:lastModifiedBy>
  <cp:revision>24</cp:revision>
  <dcterms:created xsi:type="dcterms:W3CDTF">2020-10-24T12:47:24Z</dcterms:created>
  <dcterms:modified xsi:type="dcterms:W3CDTF">2022-10-25T13:54:39Z</dcterms:modified>
</cp:coreProperties>
</file>